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8280400" cy="5400675"/>
  <p:notesSz cx="6858000" cy="9144000"/>
  <p:defaultTextStyle>
    <a:defPPr>
      <a:defRPr lang="es-ES"/>
    </a:defPPr>
    <a:lvl1pPr marL="0" algn="l" defTabSz="78167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390838" algn="l" defTabSz="78167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781677" algn="l" defTabSz="78167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172516" algn="l" defTabSz="78167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563354" algn="l" defTabSz="78167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1954192" algn="l" defTabSz="78167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345031" algn="l" defTabSz="78167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735869" algn="l" defTabSz="78167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126707" algn="l" defTabSz="78167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206" y="-90"/>
      </p:cViewPr>
      <p:guideLst>
        <p:guide orient="horz" pos="1701"/>
        <p:guide pos="26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1" y="1677710"/>
            <a:ext cx="7038340" cy="115764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42061" y="3060384"/>
            <a:ext cx="5796280" cy="138017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908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816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725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633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541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450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358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267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9986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061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65366" y="147519"/>
            <a:ext cx="1539638" cy="314414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141" y="147519"/>
            <a:ext cx="4485217" cy="314414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9355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0740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4094" y="3470435"/>
            <a:ext cx="7038340" cy="1072634"/>
          </a:xfrm>
        </p:spPr>
        <p:txBody>
          <a:bodyPr anchor="t"/>
          <a:lstStyle>
            <a:lvl1pPr algn="l">
              <a:defRPr sz="35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4094" y="2289037"/>
            <a:ext cx="7038340" cy="1181398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9083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8167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7251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6335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5419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3450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73586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12670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742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143" y="860108"/>
            <a:ext cx="3011708" cy="2431554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91856" y="860108"/>
            <a:ext cx="3013146" cy="2431554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87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1" y="216277"/>
            <a:ext cx="7452360" cy="900113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4020" y="1208902"/>
            <a:ext cx="3658615" cy="503812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90838" indent="0">
              <a:buNone/>
              <a:defRPr sz="1700" b="1"/>
            </a:lvl2pPr>
            <a:lvl3pPr marL="781677" indent="0">
              <a:buNone/>
              <a:defRPr sz="1600" b="1"/>
            </a:lvl3pPr>
            <a:lvl4pPr marL="1172516" indent="0">
              <a:buNone/>
              <a:defRPr sz="1300" b="1"/>
            </a:lvl4pPr>
            <a:lvl5pPr marL="1563354" indent="0">
              <a:buNone/>
              <a:defRPr sz="1300" b="1"/>
            </a:lvl5pPr>
            <a:lvl6pPr marL="1954192" indent="0">
              <a:buNone/>
              <a:defRPr sz="1300" b="1"/>
            </a:lvl6pPr>
            <a:lvl7pPr marL="2345031" indent="0">
              <a:buNone/>
              <a:defRPr sz="1300" b="1"/>
            </a:lvl7pPr>
            <a:lvl8pPr marL="2735869" indent="0">
              <a:buNone/>
              <a:defRPr sz="1300" b="1"/>
            </a:lvl8pPr>
            <a:lvl9pPr marL="3126707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4020" y="1712714"/>
            <a:ext cx="3658615" cy="3111639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6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206329" y="1208902"/>
            <a:ext cx="3660052" cy="503812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90838" indent="0">
              <a:buNone/>
              <a:defRPr sz="1700" b="1"/>
            </a:lvl2pPr>
            <a:lvl3pPr marL="781677" indent="0">
              <a:buNone/>
              <a:defRPr sz="1600" b="1"/>
            </a:lvl3pPr>
            <a:lvl4pPr marL="1172516" indent="0">
              <a:buNone/>
              <a:defRPr sz="1300" b="1"/>
            </a:lvl4pPr>
            <a:lvl5pPr marL="1563354" indent="0">
              <a:buNone/>
              <a:defRPr sz="1300" b="1"/>
            </a:lvl5pPr>
            <a:lvl6pPr marL="1954192" indent="0">
              <a:buNone/>
              <a:defRPr sz="1300" b="1"/>
            </a:lvl6pPr>
            <a:lvl7pPr marL="2345031" indent="0">
              <a:buNone/>
              <a:defRPr sz="1300" b="1"/>
            </a:lvl7pPr>
            <a:lvl8pPr marL="2735869" indent="0">
              <a:buNone/>
              <a:defRPr sz="1300" b="1"/>
            </a:lvl8pPr>
            <a:lvl9pPr marL="3126707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206329" y="1712714"/>
            <a:ext cx="3660052" cy="3111639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6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8889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633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2913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2" y="215026"/>
            <a:ext cx="2724194" cy="915115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37406" y="215028"/>
            <a:ext cx="4628974" cy="4609327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4022" y="1130141"/>
            <a:ext cx="2724194" cy="3694212"/>
          </a:xfrm>
        </p:spPr>
        <p:txBody>
          <a:bodyPr/>
          <a:lstStyle>
            <a:lvl1pPr marL="0" indent="0">
              <a:buNone/>
              <a:defRPr sz="1200"/>
            </a:lvl1pPr>
            <a:lvl2pPr marL="390838" indent="0">
              <a:buNone/>
              <a:defRPr sz="1000"/>
            </a:lvl2pPr>
            <a:lvl3pPr marL="781677" indent="0">
              <a:buNone/>
              <a:defRPr sz="900"/>
            </a:lvl3pPr>
            <a:lvl4pPr marL="1172516" indent="0">
              <a:buNone/>
              <a:defRPr sz="800"/>
            </a:lvl4pPr>
            <a:lvl5pPr marL="1563354" indent="0">
              <a:buNone/>
              <a:defRPr sz="800"/>
            </a:lvl5pPr>
            <a:lvl6pPr marL="1954192" indent="0">
              <a:buNone/>
              <a:defRPr sz="800"/>
            </a:lvl6pPr>
            <a:lvl7pPr marL="2345031" indent="0">
              <a:buNone/>
              <a:defRPr sz="800"/>
            </a:lvl7pPr>
            <a:lvl8pPr marL="2735869" indent="0">
              <a:buNone/>
              <a:defRPr sz="800"/>
            </a:lvl8pPr>
            <a:lvl9pPr marL="3126707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5453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3016" y="3780472"/>
            <a:ext cx="4968240" cy="446306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623016" y="482560"/>
            <a:ext cx="4968240" cy="3240405"/>
          </a:xfrm>
        </p:spPr>
        <p:txBody>
          <a:bodyPr/>
          <a:lstStyle>
            <a:lvl1pPr marL="0" indent="0">
              <a:buNone/>
              <a:defRPr sz="2700"/>
            </a:lvl1pPr>
            <a:lvl2pPr marL="390838" indent="0">
              <a:buNone/>
              <a:defRPr sz="2300"/>
            </a:lvl2pPr>
            <a:lvl3pPr marL="781677" indent="0">
              <a:buNone/>
              <a:defRPr sz="2000"/>
            </a:lvl3pPr>
            <a:lvl4pPr marL="1172516" indent="0">
              <a:buNone/>
              <a:defRPr sz="1700"/>
            </a:lvl4pPr>
            <a:lvl5pPr marL="1563354" indent="0">
              <a:buNone/>
              <a:defRPr sz="1700"/>
            </a:lvl5pPr>
            <a:lvl6pPr marL="1954192" indent="0">
              <a:buNone/>
              <a:defRPr sz="1700"/>
            </a:lvl6pPr>
            <a:lvl7pPr marL="2345031" indent="0">
              <a:buNone/>
              <a:defRPr sz="1700"/>
            </a:lvl7pPr>
            <a:lvl8pPr marL="2735869" indent="0">
              <a:buNone/>
              <a:defRPr sz="1700"/>
            </a:lvl8pPr>
            <a:lvl9pPr marL="3126707" indent="0">
              <a:buNone/>
              <a:defRPr sz="17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23016" y="4226778"/>
            <a:ext cx="4968240" cy="633829"/>
          </a:xfrm>
        </p:spPr>
        <p:txBody>
          <a:bodyPr/>
          <a:lstStyle>
            <a:lvl1pPr marL="0" indent="0">
              <a:buNone/>
              <a:defRPr sz="1200"/>
            </a:lvl1pPr>
            <a:lvl2pPr marL="390838" indent="0">
              <a:buNone/>
              <a:defRPr sz="1000"/>
            </a:lvl2pPr>
            <a:lvl3pPr marL="781677" indent="0">
              <a:buNone/>
              <a:defRPr sz="900"/>
            </a:lvl3pPr>
            <a:lvl4pPr marL="1172516" indent="0">
              <a:buNone/>
              <a:defRPr sz="800"/>
            </a:lvl4pPr>
            <a:lvl5pPr marL="1563354" indent="0">
              <a:buNone/>
              <a:defRPr sz="800"/>
            </a:lvl5pPr>
            <a:lvl6pPr marL="1954192" indent="0">
              <a:buNone/>
              <a:defRPr sz="800"/>
            </a:lvl6pPr>
            <a:lvl7pPr marL="2345031" indent="0">
              <a:buNone/>
              <a:defRPr sz="800"/>
            </a:lvl7pPr>
            <a:lvl8pPr marL="2735869" indent="0">
              <a:buNone/>
              <a:defRPr sz="800"/>
            </a:lvl8pPr>
            <a:lvl9pPr marL="3126707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6603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14021" y="216277"/>
            <a:ext cx="7452360" cy="900113"/>
          </a:xfrm>
          <a:prstGeom prst="rect">
            <a:avLst/>
          </a:prstGeom>
        </p:spPr>
        <p:txBody>
          <a:bodyPr vert="horz" lIns="78167" tIns="39084" rIns="78167" bIns="39084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4021" y="1260159"/>
            <a:ext cx="7452360" cy="3564196"/>
          </a:xfrm>
          <a:prstGeom prst="rect">
            <a:avLst/>
          </a:prstGeom>
        </p:spPr>
        <p:txBody>
          <a:bodyPr vert="horz" lIns="78167" tIns="39084" rIns="78167" bIns="3908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14020" y="5005626"/>
            <a:ext cx="1932094" cy="287536"/>
          </a:xfrm>
          <a:prstGeom prst="rect">
            <a:avLst/>
          </a:prstGeom>
        </p:spPr>
        <p:txBody>
          <a:bodyPr vert="horz" lIns="78167" tIns="39084" rIns="78167" bIns="39084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6D17B-3C99-479C-BD89-0E3C691D0CF6}" type="datetimeFigureOut">
              <a:rPr lang="es-ES" smtClean="0"/>
              <a:t>28/02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29137" y="5005626"/>
            <a:ext cx="2622127" cy="287536"/>
          </a:xfrm>
          <a:prstGeom prst="rect">
            <a:avLst/>
          </a:prstGeom>
        </p:spPr>
        <p:txBody>
          <a:bodyPr vert="horz" lIns="78167" tIns="39084" rIns="78167" bIns="39084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934287" y="5005626"/>
            <a:ext cx="1932094" cy="287536"/>
          </a:xfrm>
          <a:prstGeom prst="rect">
            <a:avLst/>
          </a:prstGeom>
        </p:spPr>
        <p:txBody>
          <a:bodyPr vert="horz" lIns="78167" tIns="39084" rIns="78167" bIns="39084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52416E-27BC-42D2-B7E9-C6C72246DFC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1207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81677" rtl="0" eaLnBrk="1" latinLnBrk="0" hangingPunct="1">
        <a:spcBef>
          <a:spcPct val="0"/>
        </a:spcBef>
        <a:buNone/>
        <a:defRPr sz="3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3129" indent="-293129" algn="l" defTabSz="781677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35112" indent="-244274" algn="l" defTabSz="781677" rtl="0" eaLnBrk="1" latinLnBrk="0" hangingPunct="1">
        <a:spcBef>
          <a:spcPct val="20000"/>
        </a:spcBef>
        <a:buFont typeface="Arial" panose="020B0604020202020204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977096" indent="-195419" algn="l" defTabSz="78167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367935" indent="-195419" algn="l" defTabSz="781677" rtl="0" eaLnBrk="1" latinLnBrk="0" hangingPunct="1">
        <a:spcBef>
          <a:spcPct val="20000"/>
        </a:spcBef>
        <a:buFont typeface="Arial" panose="020B0604020202020204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58773" indent="-195419" algn="l" defTabSz="781677" rtl="0" eaLnBrk="1" latinLnBrk="0" hangingPunct="1">
        <a:spcBef>
          <a:spcPct val="20000"/>
        </a:spcBef>
        <a:buFont typeface="Arial" panose="020B0604020202020204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49612" indent="-195419" algn="l" defTabSz="781677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40450" indent="-195419" algn="l" defTabSz="781677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1288" indent="-195419" algn="l" defTabSz="781677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22126" indent="-195419" algn="l" defTabSz="781677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78167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390838" algn="l" defTabSz="78167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81677" algn="l" defTabSz="78167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172516" algn="l" defTabSz="78167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563354" algn="l" defTabSz="78167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954192" algn="l" defTabSz="78167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45031" algn="l" defTabSz="78167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35869" algn="l" defTabSz="78167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26707" algn="l" defTabSz="781677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16149" y="298144"/>
            <a:ext cx="6565866" cy="4634441"/>
            <a:chOff x="616149" y="298144"/>
            <a:chExt cx="6565866" cy="4634441"/>
          </a:xfrm>
        </p:grpSpPr>
        <p:sp>
          <p:nvSpPr>
            <p:cNvPr id="148" name="Oval 130" descr="Diagonal hacia arriba ancha"/>
            <p:cNvSpPr>
              <a:spLocks noChangeArrowheads="1"/>
            </p:cNvSpPr>
            <p:nvPr/>
          </p:nvSpPr>
          <p:spPr bwMode="auto">
            <a:xfrm>
              <a:off x="5893933" y="3854741"/>
              <a:ext cx="281962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54" name="Line 79"/>
            <p:cNvSpPr>
              <a:spLocks noChangeShapeType="1"/>
            </p:cNvSpPr>
            <p:nvPr/>
          </p:nvSpPr>
          <p:spPr bwMode="auto">
            <a:xfrm>
              <a:off x="6175895" y="4020023"/>
              <a:ext cx="18259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ker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Line 84"/>
            <p:cNvSpPr>
              <a:spLocks noChangeShapeType="1"/>
            </p:cNvSpPr>
            <p:nvPr/>
          </p:nvSpPr>
          <p:spPr bwMode="auto">
            <a:xfrm flipH="1">
              <a:off x="6190800" y="3088648"/>
              <a:ext cx="1689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ker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Freeform 80"/>
            <p:cNvSpPr>
              <a:spLocks/>
            </p:cNvSpPr>
            <p:nvPr/>
          </p:nvSpPr>
          <p:spPr bwMode="auto">
            <a:xfrm rot="2280699">
              <a:off x="4648083" y="3543478"/>
              <a:ext cx="989973" cy="710595"/>
            </a:xfrm>
            <a:custGeom>
              <a:avLst/>
              <a:gdLst>
                <a:gd name="T0" fmla="*/ 1638 w 1265458"/>
                <a:gd name="T1" fmla="*/ 176553 h 934362"/>
                <a:gd name="T2" fmla="*/ 233497 w 1265458"/>
                <a:gd name="T3" fmla="*/ 614822 h 934362"/>
                <a:gd name="T4" fmla="*/ 30621 w 1265458"/>
                <a:gd name="T5" fmla="*/ 936217 h 934362"/>
                <a:gd name="T6" fmla="*/ 508839 w 1265458"/>
                <a:gd name="T7" fmla="*/ 804738 h 934362"/>
                <a:gd name="T8" fmla="*/ 842146 w 1265458"/>
                <a:gd name="T9" fmla="*/ 892391 h 934362"/>
                <a:gd name="T10" fmla="*/ 900110 w 1265458"/>
                <a:gd name="T11" fmla="*/ 527168 h 934362"/>
                <a:gd name="T12" fmla="*/ 1262401 w 1265458"/>
                <a:gd name="T13" fmla="*/ 191163 h 934362"/>
                <a:gd name="T14" fmla="*/ 769689 w 1265458"/>
                <a:gd name="T15" fmla="*/ 1247 h 934362"/>
                <a:gd name="T16" fmla="*/ 552317 w 1265458"/>
                <a:gd name="T17" fmla="*/ 278816 h 934362"/>
                <a:gd name="T18" fmla="*/ 378415 w 1265458"/>
                <a:gd name="T19" fmla="*/ 161944 h 934362"/>
                <a:gd name="T20" fmla="*/ 1638 w 1265458"/>
                <a:gd name="T21" fmla="*/ 176553 h 934362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1265458" h="934362">
                  <a:moveTo>
                    <a:pt x="1638" y="175410"/>
                  </a:moveTo>
                  <a:cubicBezTo>
                    <a:pt x="-22552" y="250400"/>
                    <a:pt x="229028" y="485048"/>
                    <a:pt x="233866" y="610838"/>
                  </a:cubicBezTo>
                  <a:cubicBezTo>
                    <a:pt x="238704" y="736628"/>
                    <a:pt x="-15296" y="898705"/>
                    <a:pt x="30666" y="930153"/>
                  </a:cubicBezTo>
                  <a:cubicBezTo>
                    <a:pt x="76628" y="961601"/>
                    <a:pt x="374171" y="806781"/>
                    <a:pt x="509638" y="799524"/>
                  </a:cubicBezTo>
                  <a:cubicBezTo>
                    <a:pt x="645105" y="792267"/>
                    <a:pt x="778152" y="932572"/>
                    <a:pt x="843466" y="886610"/>
                  </a:cubicBezTo>
                  <a:cubicBezTo>
                    <a:pt x="908780" y="840648"/>
                    <a:pt x="831371" y="639867"/>
                    <a:pt x="901523" y="523753"/>
                  </a:cubicBezTo>
                  <a:cubicBezTo>
                    <a:pt x="971675" y="407639"/>
                    <a:pt x="1286152" y="277010"/>
                    <a:pt x="1264381" y="189924"/>
                  </a:cubicBezTo>
                  <a:cubicBezTo>
                    <a:pt x="1242610" y="102838"/>
                    <a:pt x="889428" y="-13276"/>
                    <a:pt x="770895" y="1238"/>
                  </a:cubicBezTo>
                  <a:cubicBezTo>
                    <a:pt x="652362" y="15752"/>
                    <a:pt x="618495" y="250401"/>
                    <a:pt x="553181" y="277010"/>
                  </a:cubicBezTo>
                  <a:cubicBezTo>
                    <a:pt x="487867" y="303620"/>
                    <a:pt x="470933" y="177828"/>
                    <a:pt x="379009" y="160895"/>
                  </a:cubicBezTo>
                  <a:cubicBezTo>
                    <a:pt x="287085" y="143962"/>
                    <a:pt x="25828" y="100420"/>
                    <a:pt x="1638" y="175410"/>
                  </a:cubicBezTo>
                  <a:close/>
                </a:path>
              </a:pathLst>
            </a:custGeom>
            <a:solidFill>
              <a:srgbClr val="4D4D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cap="flat" cmpd="sng" algn="ctr">
                  <a:solidFill>
                    <a:srgbClr val="000000"/>
                  </a:solidFill>
                  <a:prstDash val="solid"/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es-ES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Oval 81" descr="Diagonal hacia arriba ancha"/>
            <p:cNvSpPr>
              <a:spLocks noChangeArrowheads="1"/>
            </p:cNvSpPr>
            <p:nvPr/>
          </p:nvSpPr>
          <p:spPr bwMode="auto">
            <a:xfrm>
              <a:off x="1599911" y="307796"/>
              <a:ext cx="280720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58" name="Oval 82" descr="Diagonal hacia arriba ancha"/>
            <p:cNvSpPr>
              <a:spLocks noChangeArrowheads="1"/>
            </p:cNvSpPr>
            <p:nvPr/>
          </p:nvSpPr>
          <p:spPr bwMode="auto">
            <a:xfrm>
              <a:off x="1976275" y="325892"/>
              <a:ext cx="281962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59" name="Oval 83" descr="Diagonal hacia arriba ancha"/>
            <p:cNvSpPr>
              <a:spLocks noChangeArrowheads="1"/>
            </p:cNvSpPr>
            <p:nvPr/>
          </p:nvSpPr>
          <p:spPr bwMode="auto">
            <a:xfrm>
              <a:off x="1637175" y="697477"/>
              <a:ext cx="281962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60" name="Oval 84" descr="Diagonal hacia arriba ancha"/>
            <p:cNvSpPr>
              <a:spLocks noChangeArrowheads="1"/>
            </p:cNvSpPr>
            <p:nvPr/>
          </p:nvSpPr>
          <p:spPr bwMode="auto">
            <a:xfrm>
              <a:off x="1989938" y="698683"/>
              <a:ext cx="281962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61" name="TextBox 85"/>
            <p:cNvSpPr txBox="1">
              <a:spLocks noChangeArrowheads="1"/>
            </p:cNvSpPr>
            <p:nvPr/>
          </p:nvSpPr>
          <p:spPr bwMode="auto">
            <a:xfrm>
              <a:off x="1187872" y="900160"/>
              <a:ext cx="1468672" cy="307777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pt-PT" altLang="en-US" sz="1400" kern="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ponder cells</a:t>
              </a:r>
              <a:endParaRPr lang="en-US" altLang="en-US" sz="14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Oval 86"/>
            <p:cNvSpPr>
              <a:spLocks noChangeArrowheads="1"/>
            </p:cNvSpPr>
            <p:nvPr/>
          </p:nvSpPr>
          <p:spPr bwMode="auto">
            <a:xfrm>
              <a:off x="3203493" y="298144"/>
              <a:ext cx="281962" cy="273862"/>
            </a:xfrm>
            <a:prstGeom prst="ellipse">
              <a:avLst/>
            </a:prstGeom>
            <a:solidFill>
              <a:srgbClr val="777777"/>
            </a:solid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63" name="Oval 87"/>
            <p:cNvSpPr>
              <a:spLocks noChangeArrowheads="1"/>
            </p:cNvSpPr>
            <p:nvPr/>
          </p:nvSpPr>
          <p:spPr bwMode="auto">
            <a:xfrm>
              <a:off x="3581099" y="316240"/>
              <a:ext cx="281962" cy="272656"/>
            </a:xfrm>
            <a:prstGeom prst="ellipse">
              <a:avLst/>
            </a:prstGeom>
            <a:solidFill>
              <a:srgbClr val="777777"/>
            </a:solid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64" name="Oval 88"/>
            <p:cNvSpPr>
              <a:spLocks noChangeArrowheads="1"/>
            </p:cNvSpPr>
            <p:nvPr/>
          </p:nvSpPr>
          <p:spPr bwMode="auto">
            <a:xfrm>
              <a:off x="3243241" y="626297"/>
              <a:ext cx="281962" cy="273862"/>
            </a:xfrm>
            <a:prstGeom prst="ellipse">
              <a:avLst/>
            </a:prstGeom>
            <a:solidFill>
              <a:srgbClr val="777777"/>
            </a:solid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65" name="Oval 89"/>
            <p:cNvSpPr>
              <a:spLocks noChangeArrowheads="1"/>
            </p:cNvSpPr>
            <p:nvPr/>
          </p:nvSpPr>
          <p:spPr bwMode="auto">
            <a:xfrm>
              <a:off x="3597246" y="627503"/>
              <a:ext cx="280720" cy="273863"/>
            </a:xfrm>
            <a:prstGeom prst="ellipse">
              <a:avLst/>
            </a:prstGeom>
            <a:solidFill>
              <a:srgbClr val="777777"/>
            </a:solid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66" name="TextBox 90"/>
            <p:cNvSpPr txBox="1">
              <a:spLocks noChangeArrowheads="1"/>
            </p:cNvSpPr>
            <p:nvPr/>
          </p:nvSpPr>
          <p:spPr bwMode="auto">
            <a:xfrm>
              <a:off x="2844586" y="913430"/>
              <a:ext cx="1399742" cy="307777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pt-PT" altLang="en-US" sz="1400" kern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imulator cells</a:t>
              </a:r>
              <a:endParaRPr lang="en-US" altLang="en-US" sz="1400" kern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7" name="Straight Arrow Connector 91"/>
            <p:cNvCxnSpPr>
              <a:cxnSpLocks noChangeShapeType="1"/>
            </p:cNvCxnSpPr>
            <p:nvPr/>
          </p:nvCxnSpPr>
          <p:spPr bwMode="auto">
            <a:xfrm>
              <a:off x="1976275" y="1198151"/>
              <a:ext cx="0" cy="564616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arrow" w="med" len="med"/>
            </a:ln>
            <a:effectLst>
              <a:outerShdw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68" name="Straight Arrow Connector 92"/>
            <p:cNvCxnSpPr>
              <a:cxnSpLocks noChangeShapeType="1"/>
            </p:cNvCxnSpPr>
            <p:nvPr/>
          </p:nvCxnSpPr>
          <p:spPr bwMode="auto">
            <a:xfrm>
              <a:off x="3603457" y="1198151"/>
              <a:ext cx="0" cy="564616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arrow" w="med" len="med"/>
            </a:ln>
            <a:effectLst>
              <a:outerShdw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69" name="TextBox 93"/>
            <p:cNvSpPr txBox="1">
              <a:spLocks noChangeArrowheads="1"/>
            </p:cNvSpPr>
            <p:nvPr/>
          </p:nvSpPr>
          <p:spPr bwMode="auto">
            <a:xfrm>
              <a:off x="3598861" y="1288031"/>
              <a:ext cx="201369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pt-PT" alt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nhibition of proliferation</a:t>
              </a:r>
              <a:endParaRPr lang="en-US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70" name="TextBox 94"/>
            <p:cNvSpPr txBox="1">
              <a:spLocks noChangeArrowheads="1"/>
            </p:cNvSpPr>
            <p:nvPr/>
          </p:nvSpPr>
          <p:spPr bwMode="auto">
            <a:xfrm>
              <a:off x="672448" y="1288031"/>
              <a:ext cx="131638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pt-PT" alt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CFSE Labelling</a:t>
              </a:r>
              <a:endParaRPr lang="en-US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71" name="Oval 95" descr="Diagonal hacia arriba ancha"/>
            <p:cNvSpPr>
              <a:spLocks noChangeArrowheads="1"/>
            </p:cNvSpPr>
            <p:nvPr/>
          </p:nvSpPr>
          <p:spPr bwMode="auto">
            <a:xfrm>
              <a:off x="1647112" y="1864108"/>
              <a:ext cx="281962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72" name="Oval 96" descr="Diagonal hacia arriba ancha"/>
            <p:cNvSpPr>
              <a:spLocks noChangeArrowheads="1"/>
            </p:cNvSpPr>
            <p:nvPr/>
          </p:nvSpPr>
          <p:spPr bwMode="auto">
            <a:xfrm>
              <a:off x="2024717" y="1882204"/>
              <a:ext cx="280720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73" name="Oval 97" descr="Diagonal hacia arriba ancha"/>
            <p:cNvSpPr>
              <a:spLocks noChangeArrowheads="1"/>
            </p:cNvSpPr>
            <p:nvPr/>
          </p:nvSpPr>
          <p:spPr bwMode="auto">
            <a:xfrm>
              <a:off x="1684376" y="2253789"/>
              <a:ext cx="281962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74" name="Oval 98" descr="Diagonal hacia arriba ancha"/>
            <p:cNvSpPr>
              <a:spLocks noChangeArrowheads="1"/>
            </p:cNvSpPr>
            <p:nvPr/>
          </p:nvSpPr>
          <p:spPr bwMode="auto">
            <a:xfrm>
              <a:off x="2038381" y="2254996"/>
              <a:ext cx="280720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75" name="Oval 99"/>
            <p:cNvSpPr>
              <a:spLocks noChangeArrowheads="1"/>
            </p:cNvSpPr>
            <p:nvPr/>
          </p:nvSpPr>
          <p:spPr bwMode="auto">
            <a:xfrm>
              <a:off x="3251936" y="1897889"/>
              <a:ext cx="280720" cy="273862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76" name="Oval 100"/>
            <p:cNvSpPr>
              <a:spLocks noChangeArrowheads="1"/>
            </p:cNvSpPr>
            <p:nvPr/>
          </p:nvSpPr>
          <p:spPr bwMode="auto">
            <a:xfrm>
              <a:off x="3628300" y="1915985"/>
              <a:ext cx="281962" cy="272656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77" name="Oval 101"/>
            <p:cNvSpPr>
              <a:spLocks noChangeArrowheads="1"/>
            </p:cNvSpPr>
            <p:nvPr/>
          </p:nvSpPr>
          <p:spPr bwMode="auto">
            <a:xfrm>
              <a:off x="3291684" y="2226041"/>
              <a:ext cx="280720" cy="273862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78" name="Oval 102"/>
            <p:cNvSpPr>
              <a:spLocks noChangeArrowheads="1"/>
            </p:cNvSpPr>
            <p:nvPr/>
          </p:nvSpPr>
          <p:spPr bwMode="auto">
            <a:xfrm>
              <a:off x="3644447" y="2227247"/>
              <a:ext cx="281962" cy="273863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79" name="Left Bracket 103"/>
            <p:cNvSpPr>
              <a:spLocks/>
            </p:cNvSpPr>
            <p:nvPr/>
          </p:nvSpPr>
          <p:spPr bwMode="auto">
            <a:xfrm rot="16200000">
              <a:off x="2707406" y="1162357"/>
              <a:ext cx="219573" cy="2576165"/>
            </a:xfrm>
            <a:prstGeom prst="leftBracket">
              <a:avLst>
                <a:gd name="adj" fmla="val 8336"/>
              </a:avLst>
            </a:prstGeom>
            <a:noFill/>
            <a:ln w="25400" algn="ctr">
              <a:solidFill>
                <a:srgbClr val="000000"/>
              </a:solidFill>
              <a:round/>
              <a:headEnd/>
              <a:tailEnd/>
            </a:ln>
            <a:effectLst>
              <a:outerShdw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eaVert" anchor="ctr"/>
            <a:lstStyle/>
            <a:p>
              <a:pPr algn="ctr">
                <a:defRPr/>
              </a:pPr>
              <a:endParaRPr lang="en-US" kern="0">
                <a:solidFill>
                  <a:sysClr val="windowText" lastClr="000000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80" name="TextBox 104"/>
            <p:cNvSpPr txBox="1">
              <a:spLocks noChangeArrowheads="1"/>
            </p:cNvSpPr>
            <p:nvPr/>
          </p:nvSpPr>
          <p:spPr bwMode="auto">
            <a:xfrm>
              <a:off x="616149" y="2368402"/>
              <a:ext cx="806631" cy="323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pt-PT" altLang="en-US" sz="150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Culture</a:t>
              </a:r>
              <a:endParaRPr lang="en-US" altLang="en-US" sz="150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81" name="TextBox 105"/>
            <p:cNvSpPr txBox="1">
              <a:spLocks noChangeArrowheads="1"/>
            </p:cNvSpPr>
            <p:nvPr/>
          </p:nvSpPr>
          <p:spPr bwMode="auto">
            <a:xfrm>
              <a:off x="1217336" y="4380336"/>
              <a:ext cx="2863095" cy="3248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pt-PT" altLang="en-US" sz="1500" b="1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Mixed </a:t>
              </a:r>
              <a:r>
                <a:rPr lang="pt-PT" altLang="en-US" sz="1500" b="1" dirty="0" smtClean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leukocyte reaction</a:t>
              </a:r>
              <a:endParaRPr lang="en-US" altLang="en-US" sz="15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82" name="Oval 106" descr="Diagonal hacia arriba ancha"/>
            <p:cNvSpPr>
              <a:spLocks noChangeArrowheads="1"/>
            </p:cNvSpPr>
            <p:nvPr/>
          </p:nvSpPr>
          <p:spPr bwMode="auto">
            <a:xfrm>
              <a:off x="2639569" y="2934223"/>
              <a:ext cx="280720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83" name="Oval 107" descr="Diagonal hacia arriba ancha"/>
            <p:cNvSpPr>
              <a:spLocks noChangeArrowheads="1"/>
            </p:cNvSpPr>
            <p:nvPr/>
          </p:nvSpPr>
          <p:spPr bwMode="auto">
            <a:xfrm>
              <a:off x="3015932" y="2951114"/>
              <a:ext cx="281962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84" name="Oval 108" descr="Diagonal hacia arriba ancha"/>
            <p:cNvSpPr>
              <a:spLocks noChangeArrowheads="1"/>
            </p:cNvSpPr>
            <p:nvPr/>
          </p:nvSpPr>
          <p:spPr bwMode="auto">
            <a:xfrm>
              <a:off x="2676833" y="3323905"/>
              <a:ext cx="281962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85" name="Oval 109" descr="Diagonal hacia arriba ancha"/>
            <p:cNvSpPr>
              <a:spLocks noChangeArrowheads="1"/>
            </p:cNvSpPr>
            <p:nvPr/>
          </p:nvSpPr>
          <p:spPr bwMode="auto">
            <a:xfrm>
              <a:off x="3487939" y="3672567"/>
              <a:ext cx="281962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86" name="Oval 110" descr="Diagonal hacia arriba ancha"/>
            <p:cNvSpPr>
              <a:spLocks noChangeArrowheads="1"/>
            </p:cNvSpPr>
            <p:nvPr/>
          </p:nvSpPr>
          <p:spPr bwMode="auto">
            <a:xfrm>
              <a:off x="1966338" y="3065726"/>
              <a:ext cx="281962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87" name="Oval 111" descr="Diagonal hacia arriba ancha"/>
            <p:cNvSpPr>
              <a:spLocks noChangeArrowheads="1"/>
            </p:cNvSpPr>
            <p:nvPr/>
          </p:nvSpPr>
          <p:spPr bwMode="auto">
            <a:xfrm>
              <a:off x="2050802" y="3810102"/>
              <a:ext cx="281962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88" name="Oval 112" descr="Diagonal hacia arriba ancha"/>
            <p:cNvSpPr>
              <a:spLocks noChangeArrowheads="1"/>
            </p:cNvSpPr>
            <p:nvPr/>
          </p:nvSpPr>
          <p:spPr bwMode="auto">
            <a:xfrm>
              <a:off x="2003602" y="3455407"/>
              <a:ext cx="281962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89" name="Oval 113" descr="Diagonal hacia arriba ancha"/>
            <p:cNvSpPr>
              <a:spLocks noChangeArrowheads="1"/>
            </p:cNvSpPr>
            <p:nvPr/>
          </p:nvSpPr>
          <p:spPr bwMode="auto">
            <a:xfrm>
              <a:off x="2357607" y="3456614"/>
              <a:ext cx="281962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90" name="Oval 114" descr="Diagonal hacia arriba ancha"/>
            <p:cNvSpPr>
              <a:spLocks noChangeArrowheads="1"/>
            </p:cNvSpPr>
            <p:nvPr/>
          </p:nvSpPr>
          <p:spPr bwMode="auto">
            <a:xfrm>
              <a:off x="2710370" y="3668948"/>
              <a:ext cx="281962" cy="272656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91" name="Oval 115" descr="Diagonal hacia arriba ancha"/>
            <p:cNvSpPr>
              <a:spLocks noChangeArrowheads="1"/>
            </p:cNvSpPr>
            <p:nvPr/>
          </p:nvSpPr>
          <p:spPr bwMode="auto">
            <a:xfrm>
              <a:off x="3087975" y="3685838"/>
              <a:ext cx="281962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92" name="Oval 116" descr="Diagonal hacia arriba ancha"/>
            <p:cNvSpPr>
              <a:spLocks noChangeArrowheads="1"/>
            </p:cNvSpPr>
            <p:nvPr/>
          </p:nvSpPr>
          <p:spPr bwMode="auto">
            <a:xfrm rot="11947377">
              <a:off x="3387328" y="3048836"/>
              <a:ext cx="281962" cy="272656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rot="10800000"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93" name="Oval 117" descr="Diagonal hacia arriba ancha"/>
            <p:cNvSpPr>
              <a:spLocks noChangeArrowheads="1"/>
            </p:cNvSpPr>
            <p:nvPr/>
          </p:nvSpPr>
          <p:spPr bwMode="auto">
            <a:xfrm rot="11947377">
              <a:off x="3432044" y="3379402"/>
              <a:ext cx="281962" cy="273862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rot="10800000"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94" name="Oval 118"/>
            <p:cNvSpPr>
              <a:spLocks noChangeArrowheads="1"/>
            </p:cNvSpPr>
            <p:nvPr/>
          </p:nvSpPr>
          <p:spPr bwMode="auto">
            <a:xfrm>
              <a:off x="2353881" y="3033152"/>
              <a:ext cx="281962" cy="273863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95" name="Oval 119"/>
            <p:cNvSpPr>
              <a:spLocks noChangeArrowheads="1"/>
            </p:cNvSpPr>
            <p:nvPr/>
          </p:nvSpPr>
          <p:spPr bwMode="auto">
            <a:xfrm>
              <a:off x="3654384" y="2913714"/>
              <a:ext cx="281962" cy="273862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96" name="Oval 120"/>
            <p:cNvSpPr>
              <a:spLocks noChangeArrowheads="1"/>
            </p:cNvSpPr>
            <p:nvPr/>
          </p:nvSpPr>
          <p:spPr bwMode="auto">
            <a:xfrm>
              <a:off x="3030838" y="3357686"/>
              <a:ext cx="281962" cy="273862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97" name="Oval 121"/>
            <p:cNvSpPr>
              <a:spLocks noChangeArrowheads="1"/>
            </p:cNvSpPr>
            <p:nvPr/>
          </p:nvSpPr>
          <p:spPr bwMode="auto">
            <a:xfrm>
              <a:off x="2389902" y="3789593"/>
              <a:ext cx="281962" cy="272656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198" name="Left Bracket 122"/>
            <p:cNvSpPr>
              <a:spLocks/>
            </p:cNvSpPr>
            <p:nvPr/>
          </p:nvSpPr>
          <p:spPr bwMode="auto">
            <a:xfrm rot="16200000">
              <a:off x="4021844" y="-181469"/>
              <a:ext cx="279895" cy="5379637"/>
            </a:xfrm>
            <a:prstGeom prst="leftBracket">
              <a:avLst>
                <a:gd name="adj" fmla="val 8297"/>
              </a:avLst>
            </a:prstGeom>
            <a:noFill/>
            <a:ln w="25400" algn="ctr">
              <a:solidFill>
                <a:srgbClr val="000000"/>
              </a:solidFill>
              <a:round/>
              <a:headEnd/>
              <a:tailEnd/>
            </a:ln>
            <a:effectLst>
              <a:outerShdw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eaVert" anchor="ctr"/>
            <a:lstStyle/>
            <a:p>
              <a:pPr algn="ctr">
                <a:defRPr/>
              </a:pPr>
              <a:endParaRPr lang="en-US" kern="0">
                <a:solidFill>
                  <a:sysClr val="windowText" lastClr="000000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200" name="TextBox 124"/>
            <p:cNvSpPr txBox="1">
              <a:spLocks noChangeArrowheads="1"/>
            </p:cNvSpPr>
            <p:nvPr/>
          </p:nvSpPr>
          <p:spPr bwMode="auto">
            <a:xfrm>
              <a:off x="1408906" y="2876061"/>
              <a:ext cx="476412" cy="584775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GB" altLang="en-US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TNF-α</a:t>
              </a: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lang="pt-PT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FN</a:t>
              </a:r>
              <a:r>
                <a:rPr lang="el-GR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γ</a:t>
              </a:r>
              <a:endParaRPr lang="en-US" altLang="en-US" sz="8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lang="en-GB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L-1β</a:t>
              </a:r>
              <a:endParaRPr lang="en-US" altLang="en-US" sz="8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lang="en-GB" altLang="en-US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L-1α</a:t>
              </a:r>
              <a:endParaRPr lang="en-US" altLang="en-US" sz="8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03" name="Freeform 127"/>
            <p:cNvSpPr>
              <a:spLocks/>
            </p:cNvSpPr>
            <p:nvPr/>
          </p:nvSpPr>
          <p:spPr bwMode="auto">
            <a:xfrm>
              <a:off x="4795896" y="1731399"/>
              <a:ext cx="991215" cy="709389"/>
            </a:xfrm>
            <a:custGeom>
              <a:avLst/>
              <a:gdLst>
                <a:gd name="T0" fmla="*/ 1656 w 1265458"/>
                <a:gd name="T1" fmla="*/ 173875 h 934362"/>
                <a:gd name="T2" fmla="*/ 236150 w 1265458"/>
                <a:gd name="T3" fmla="*/ 605493 h 934362"/>
                <a:gd name="T4" fmla="*/ 30963 w 1265458"/>
                <a:gd name="T5" fmla="*/ 922014 h 934362"/>
                <a:gd name="T6" fmla="*/ 514614 w 1265458"/>
                <a:gd name="T7" fmla="*/ 792528 h 934362"/>
                <a:gd name="T8" fmla="*/ 851701 w 1265458"/>
                <a:gd name="T9" fmla="*/ 878852 h 934362"/>
                <a:gd name="T10" fmla="*/ 910325 w 1265458"/>
                <a:gd name="T11" fmla="*/ 519170 h 934362"/>
                <a:gd name="T12" fmla="*/ 1276727 w 1265458"/>
                <a:gd name="T13" fmla="*/ 188263 h 934362"/>
                <a:gd name="T14" fmla="*/ 778422 w 1265458"/>
                <a:gd name="T15" fmla="*/ 1229 h 934362"/>
                <a:gd name="T16" fmla="*/ 558583 w 1265458"/>
                <a:gd name="T17" fmla="*/ 274586 h 934362"/>
                <a:gd name="T18" fmla="*/ 382710 w 1265458"/>
                <a:gd name="T19" fmla="*/ 159487 h 934362"/>
                <a:gd name="T20" fmla="*/ 1656 w 1265458"/>
                <a:gd name="T21" fmla="*/ 173875 h 934362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1265458" h="934362">
                  <a:moveTo>
                    <a:pt x="1638" y="175410"/>
                  </a:moveTo>
                  <a:cubicBezTo>
                    <a:pt x="-22552" y="250400"/>
                    <a:pt x="229028" y="485048"/>
                    <a:pt x="233866" y="610838"/>
                  </a:cubicBezTo>
                  <a:cubicBezTo>
                    <a:pt x="238704" y="736628"/>
                    <a:pt x="-15296" y="898705"/>
                    <a:pt x="30666" y="930153"/>
                  </a:cubicBezTo>
                  <a:cubicBezTo>
                    <a:pt x="76628" y="961601"/>
                    <a:pt x="374171" y="806781"/>
                    <a:pt x="509638" y="799524"/>
                  </a:cubicBezTo>
                  <a:cubicBezTo>
                    <a:pt x="645105" y="792267"/>
                    <a:pt x="778152" y="932572"/>
                    <a:pt x="843466" y="886610"/>
                  </a:cubicBezTo>
                  <a:cubicBezTo>
                    <a:pt x="908780" y="840648"/>
                    <a:pt x="831371" y="639867"/>
                    <a:pt x="901523" y="523753"/>
                  </a:cubicBezTo>
                  <a:cubicBezTo>
                    <a:pt x="971675" y="407639"/>
                    <a:pt x="1286152" y="277010"/>
                    <a:pt x="1264381" y="189924"/>
                  </a:cubicBezTo>
                  <a:cubicBezTo>
                    <a:pt x="1242610" y="102838"/>
                    <a:pt x="889428" y="-13276"/>
                    <a:pt x="770895" y="1238"/>
                  </a:cubicBezTo>
                  <a:cubicBezTo>
                    <a:pt x="652362" y="15752"/>
                    <a:pt x="618495" y="250401"/>
                    <a:pt x="553181" y="277010"/>
                  </a:cubicBezTo>
                  <a:cubicBezTo>
                    <a:pt x="487867" y="303620"/>
                    <a:pt x="470933" y="177828"/>
                    <a:pt x="379009" y="160895"/>
                  </a:cubicBezTo>
                  <a:cubicBezTo>
                    <a:pt x="287085" y="143962"/>
                    <a:pt x="25828" y="100420"/>
                    <a:pt x="1638" y="175410"/>
                  </a:cubicBezTo>
                  <a:close/>
                </a:path>
              </a:pathLst>
            </a:custGeom>
            <a:solidFill>
              <a:srgbClr val="4D4D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cap="flat" cmpd="sng" algn="ctr">
                  <a:solidFill>
                    <a:srgbClr val="000000"/>
                  </a:solidFill>
                  <a:prstDash val="solid"/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es-ES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TextBox 128"/>
            <p:cNvSpPr txBox="1">
              <a:spLocks noChangeArrowheads="1"/>
            </p:cNvSpPr>
            <p:nvPr/>
          </p:nvSpPr>
          <p:spPr bwMode="auto">
            <a:xfrm>
              <a:off x="5405044" y="2201576"/>
              <a:ext cx="639919" cy="338554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pt-PT" altLang="en-US" kern="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C</a:t>
              </a:r>
              <a:endParaRPr lang="en-US" altLang="en-US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Freeform 129"/>
            <p:cNvSpPr>
              <a:spLocks/>
            </p:cNvSpPr>
            <p:nvPr/>
          </p:nvSpPr>
          <p:spPr bwMode="auto">
            <a:xfrm>
              <a:off x="5256723" y="2928192"/>
              <a:ext cx="991215" cy="710595"/>
            </a:xfrm>
            <a:custGeom>
              <a:avLst/>
              <a:gdLst>
                <a:gd name="T0" fmla="*/ 1656 w 1265458"/>
                <a:gd name="T1" fmla="*/ 176553 h 934362"/>
                <a:gd name="T2" fmla="*/ 236150 w 1265458"/>
                <a:gd name="T3" fmla="*/ 614822 h 934362"/>
                <a:gd name="T4" fmla="*/ 30963 w 1265458"/>
                <a:gd name="T5" fmla="*/ 936217 h 934362"/>
                <a:gd name="T6" fmla="*/ 514614 w 1265458"/>
                <a:gd name="T7" fmla="*/ 804738 h 934362"/>
                <a:gd name="T8" fmla="*/ 851701 w 1265458"/>
                <a:gd name="T9" fmla="*/ 892391 h 934362"/>
                <a:gd name="T10" fmla="*/ 910325 w 1265458"/>
                <a:gd name="T11" fmla="*/ 527168 h 934362"/>
                <a:gd name="T12" fmla="*/ 1276727 w 1265458"/>
                <a:gd name="T13" fmla="*/ 191163 h 934362"/>
                <a:gd name="T14" fmla="*/ 778422 w 1265458"/>
                <a:gd name="T15" fmla="*/ 1247 h 934362"/>
                <a:gd name="T16" fmla="*/ 558583 w 1265458"/>
                <a:gd name="T17" fmla="*/ 278816 h 934362"/>
                <a:gd name="T18" fmla="*/ 382710 w 1265458"/>
                <a:gd name="T19" fmla="*/ 161944 h 934362"/>
                <a:gd name="T20" fmla="*/ 1656 w 1265458"/>
                <a:gd name="T21" fmla="*/ 176553 h 934362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1265458" h="934362">
                  <a:moveTo>
                    <a:pt x="1638" y="175410"/>
                  </a:moveTo>
                  <a:cubicBezTo>
                    <a:pt x="-22552" y="250400"/>
                    <a:pt x="229028" y="485048"/>
                    <a:pt x="233866" y="610838"/>
                  </a:cubicBezTo>
                  <a:cubicBezTo>
                    <a:pt x="238704" y="736628"/>
                    <a:pt x="-15296" y="898705"/>
                    <a:pt x="30666" y="930153"/>
                  </a:cubicBezTo>
                  <a:cubicBezTo>
                    <a:pt x="76628" y="961601"/>
                    <a:pt x="374171" y="806781"/>
                    <a:pt x="509638" y="799524"/>
                  </a:cubicBezTo>
                  <a:cubicBezTo>
                    <a:pt x="645105" y="792267"/>
                    <a:pt x="778152" y="932572"/>
                    <a:pt x="843466" y="886610"/>
                  </a:cubicBezTo>
                  <a:cubicBezTo>
                    <a:pt x="908780" y="840648"/>
                    <a:pt x="831371" y="639867"/>
                    <a:pt x="901523" y="523753"/>
                  </a:cubicBezTo>
                  <a:cubicBezTo>
                    <a:pt x="971675" y="407639"/>
                    <a:pt x="1286152" y="277010"/>
                    <a:pt x="1264381" y="189924"/>
                  </a:cubicBezTo>
                  <a:cubicBezTo>
                    <a:pt x="1242610" y="102838"/>
                    <a:pt x="889428" y="-13276"/>
                    <a:pt x="770895" y="1238"/>
                  </a:cubicBezTo>
                  <a:cubicBezTo>
                    <a:pt x="652362" y="15752"/>
                    <a:pt x="618495" y="250401"/>
                    <a:pt x="553181" y="277010"/>
                  </a:cubicBezTo>
                  <a:cubicBezTo>
                    <a:pt x="487867" y="303620"/>
                    <a:pt x="470933" y="177828"/>
                    <a:pt x="379009" y="160895"/>
                  </a:cubicBezTo>
                  <a:cubicBezTo>
                    <a:pt x="287085" y="143962"/>
                    <a:pt x="25828" y="100420"/>
                    <a:pt x="1638" y="175410"/>
                  </a:cubicBezTo>
                  <a:close/>
                </a:path>
              </a:pathLst>
            </a:custGeom>
            <a:solidFill>
              <a:srgbClr val="4D4D4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cap="flat" cmpd="sng" algn="ctr">
                  <a:solidFill>
                    <a:srgbClr val="000000"/>
                  </a:solidFill>
                  <a:prstDash val="solid"/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es-ES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Oval 205" descr="Diagonal hacia arriba ancha"/>
            <p:cNvSpPr>
              <a:spLocks noChangeArrowheads="1"/>
            </p:cNvSpPr>
            <p:nvPr/>
          </p:nvSpPr>
          <p:spPr bwMode="auto">
            <a:xfrm>
              <a:off x="4823223" y="2980068"/>
              <a:ext cx="281962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207" name="Oval 134" descr="Diagonal hacia arriba ancha"/>
            <p:cNvSpPr>
              <a:spLocks noChangeArrowheads="1"/>
            </p:cNvSpPr>
            <p:nvPr/>
          </p:nvSpPr>
          <p:spPr bwMode="auto">
            <a:xfrm>
              <a:off x="4372331" y="2815992"/>
              <a:ext cx="281962" cy="273863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208" name="Oval 135" descr="Diagonal hacia arriba ancha"/>
            <p:cNvSpPr>
              <a:spLocks noChangeArrowheads="1"/>
            </p:cNvSpPr>
            <p:nvPr/>
          </p:nvSpPr>
          <p:spPr bwMode="auto">
            <a:xfrm rot="11947377">
              <a:off x="4372331" y="4020023"/>
              <a:ext cx="281962" cy="272656"/>
            </a:xfrm>
            <a:prstGeom prst="ellipse">
              <a:avLst/>
            </a:prstGeom>
            <a:pattFill prst="wdUpDiag">
              <a:fgClr>
                <a:srgbClr val="777777"/>
              </a:fgClr>
              <a:bgClr>
                <a:srgbClr val="FFFFFF"/>
              </a:bgClr>
            </a:pattFill>
            <a:ln w="25400" algn="ctr">
              <a:solidFill>
                <a:srgbClr val="000000"/>
              </a:solidFill>
              <a:round/>
              <a:headEnd/>
              <a:tailEnd/>
            </a:ln>
          </p:spPr>
          <p:txBody>
            <a:bodyPr rot="10800000"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209" name="Oval 136"/>
            <p:cNvSpPr>
              <a:spLocks noChangeArrowheads="1"/>
            </p:cNvSpPr>
            <p:nvPr/>
          </p:nvSpPr>
          <p:spPr bwMode="auto">
            <a:xfrm>
              <a:off x="4316436" y="3362511"/>
              <a:ext cx="280720" cy="273862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210" name="Oval 137"/>
            <p:cNvSpPr>
              <a:spLocks noChangeArrowheads="1"/>
            </p:cNvSpPr>
            <p:nvPr/>
          </p:nvSpPr>
          <p:spPr bwMode="auto">
            <a:xfrm>
              <a:off x="5443042" y="2706206"/>
              <a:ext cx="281962" cy="272656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211" name="Oval 138"/>
            <p:cNvSpPr>
              <a:spLocks noChangeArrowheads="1"/>
            </p:cNvSpPr>
            <p:nvPr/>
          </p:nvSpPr>
          <p:spPr bwMode="auto">
            <a:xfrm>
              <a:off x="6005724" y="3430072"/>
              <a:ext cx="281962" cy="273862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sp>
          <p:nvSpPr>
            <p:cNvPr id="212" name="Oval 139"/>
            <p:cNvSpPr>
              <a:spLocks noChangeArrowheads="1"/>
            </p:cNvSpPr>
            <p:nvPr/>
          </p:nvSpPr>
          <p:spPr bwMode="auto">
            <a:xfrm>
              <a:off x="5387147" y="4074313"/>
              <a:ext cx="281962" cy="273862"/>
            </a:xfrm>
            <a:prstGeom prst="ellipse">
              <a:avLst/>
            </a:prstGeom>
            <a:solidFill>
              <a:srgbClr val="7777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endParaRPr>
            </a:p>
          </p:txBody>
        </p:sp>
        <p:cxnSp>
          <p:nvCxnSpPr>
            <p:cNvPr id="213" name="Straight Connector 144"/>
            <p:cNvCxnSpPr>
              <a:cxnSpLocks noChangeShapeType="1"/>
            </p:cNvCxnSpPr>
            <p:nvPr/>
          </p:nvCxnSpPr>
          <p:spPr bwMode="auto">
            <a:xfrm>
              <a:off x="4127633" y="2817198"/>
              <a:ext cx="0" cy="208800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14" name="TextBox 145"/>
            <p:cNvSpPr txBox="1">
              <a:spLocks noChangeArrowheads="1"/>
            </p:cNvSpPr>
            <p:nvPr/>
          </p:nvSpPr>
          <p:spPr bwMode="auto">
            <a:xfrm>
              <a:off x="4147507" y="4380336"/>
              <a:ext cx="3034508" cy="5522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pt-PT" altLang="en-US" sz="1500" b="1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mmunosupression of the MLR </a:t>
              </a:r>
            </a:p>
            <a:p>
              <a:pPr algn="ctr"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pt-PT" altLang="en-US" sz="1500" b="1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by MSCs</a:t>
              </a:r>
              <a:endParaRPr lang="en-US" altLang="en-US" sz="15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15" name="TextBox 143"/>
            <p:cNvSpPr txBox="1">
              <a:spLocks noChangeArrowheads="1"/>
            </p:cNvSpPr>
            <p:nvPr/>
          </p:nvSpPr>
          <p:spPr bwMode="auto">
            <a:xfrm>
              <a:off x="6358488" y="2793455"/>
              <a:ext cx="482824" cy="707886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TGF-</a:t>
              </a:r>
              <a:r>
                <a:rPr lang="el-GR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β</a:t>
              </a:r>
              <a:endParaRPr lang="es-ES" altLang="en-US" sz="8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s-ES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L-10</a:t>
              </a: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FN-</a:t>
              </a:r>
              <a:r>
                <a:rPr lang="el-GR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γ</a:t>
              </a:r>
              <a:endParaRPr lang="es-ES" altLang="en-US" sz="8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s-ES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PGE2</a:t>
              </a: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GB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DO</a:t>
              </a:r>
              <a:endParaRPr lang="el-GR" altLang="en-US" sz="8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17" name="Line 77"/>
            <p:cNvSpPr>
              <a:spLocks noChangeShapeType="1"/>
            </p:cNvSpPr>
            <p:nvPr/>
          </p:nvSpPr>
          <p:spPr bwMode="auto">
            <a:xfrm>
              <a:off x="1901748" y="3198435"/>
              <a:ext cx="571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ker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TextBox 124"/>
            <p:cNvSpPr txBox="1">
              <a:spLocks noChangeArrowheads="1"/>
            </p:cNvSpPr>
            <p:nvPr/>
          </p:nvSpPr>
          <p:spPr bwMode="auto">
            <a:xfrm>
              <a:off x="6358488" y="3691893"/>
              <a:ext cx="476412" cy="584775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GB" altLang="en-US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TNF-α</a:t>
              </a: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lang="pt-PT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FN</a:t>
              </a:r>
              <a:r>
                <a:rPr lang="el-GR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γ</a:t>
              </a:r>
              <a:endParaRPr lang="en-US" altLang="en-US" sz="8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lang="en-GB" alt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L-1β</a:t>
              </a:r>
              <a:endParaRPr lang="en-US" altLang="en-US" sz="8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lang="en-GB" altLang="en-US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itchFamily="34" charset="-128"/>
                  <a:cs typeface="Arial" panose="020B0604020202020204" pitchFamily="34" charset="0"/>
                </a:rPr>
                <a:t>IL-1α</a:t>
              </a:r>
              <a:endParaRPr lang="en-US" altLang="en-US" sz="8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69424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37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ntxa Blázquez Prunera</dc:creator>
  <cp:lastModifiedBy>Arantxa Blázquez Prunera</cp:lastModifiedBy>
  <cp:revision>4</cp:revision>
  <dcterms:created xsi:type="dcterms:W3CDTF">2017-02-28T13:41:42Z</dcterms:created>
  <dcterms:modified xsi:type="dcterms:W3CDTF">2017-02-28T15:50:26Z</dcterms:modified>
</cp:coreProperties>
</file>